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796" autoAdjust="0"/>
    <p:restoredTop sz="94660"/>
  </p:normalViewPr>
  <p:slideViewPr>
    <p:cSldViewPr>
      <p:cViewPr varScale="1">
        <p:scale>
          <a:sx n="48" d="100"/>
          <a:sy n="48" d="100"/>
        </p:scale>
        <p:origin x="1984" y="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14953A2-41DF-456C-8E35-D349608663FA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408A91-25A6-4FB1-9D72-7CBD7895520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1817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25D439-7D67-479D-BA16-E4467A70B23F}" type="datetimeFigureOut">
              <a:rPr lang="zh-CN" altLang="en-US" smtClean="0"/>
              <a:t>2019/7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CEAE9-45EE-4036-8DC3-68BC050ACCAF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jpeg"/><Relationship Id="rId18" Type="http://schemas.microsoft.com/office/2007/relationships/hdphoto" Target="../media/hdphoto7.wdp"/><Relationship Id="rId3" Type="http://schemas.openxmlformats.org/officeDocument/2006/relationships/image" Target="../media/image2.png"/><Relationship Id="rId21" Type="http://schemas.openxmlformats.org/officeDocument/2006/relationships/image" Target="../media/image12.png"/><Relationship Id="rId7" Type="http://schemas.openxmlformats.org/officeDocument/2006/relationships/image" Target="../media/image5.jpeg"/><Relationship Id="rId12" Type="http://schemas.microsoft.com/office/2007/relationships/hdphoto" Target="../media/hdphoto4.wdp"/><Relationship Id="rId17" Type="http://schemas.openxmlformats.org/officeDocument/2006/relationships/image" Target="../media/image10.png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20" Type="http://schemas.microsoft.com/office/2007/relationships/hdphoto" Target="../media/hdphoto8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7.jpeg"/><Relationship Id="rId5" Type="http://schemas.microsoft.com/office/2007/relationships/hdphoto" Target="../media/hdphoto1.wdp"/><Relationship Id="rId15" Type="http://schemas.openxmlformats.org/officeDocument/2006/relationships/image" Target="../media/image9.jpeg"/><Relationship Id="rId10" Type="http://schemas.microsoft.com/office/2007/relationships/hdphoto" Target="../media/hdphoto3.wdp"/><Relationship Id="rId19" Type="http://schemas.openxmlformats.org/officeDocument/2006/relationships/image" Target="../media/image11.png"/><Relationship Id="rId4" Type="http://schemas.openxmlformats.org/officeDocument/2006/relationships/image" Target="../media/image3.jpeg"/><Relationship Id="rId9" Type="http://schemas.openxmlformats.org/officeDocument/2006/relationships/image" Target="../media/image6.jpeg"/><Relationship Id="rId14" Type="http://schemas.microsoft.com/office/2007/relationships/hdphoto" Target="../media/hdphoto5.wdp"/><Relationship Id="rId22" Type="http://schemas.microsoft.com/office/2007/relationships/hdphoto" Target="../media/hdphoto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7" t="11524" b="14565"/>
          <a:stretch/>
        </p:blipFill>
        <p:spPr bwMode="auto">
          <a:xfrm>
            <a:off x="882419" y="906031"/>
            <a:ext cx="2286441" cy="150765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" name="TextBox 29"/>
          <p:cNvSpPr txBox="1"/>
          <p:nvPr/>
        </p:nvSpPr>
        <p:spPr>
          <a:xfrm>
            <a:off x="377860" y="3365918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B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377860" y="323528"/>
            <a:ext cx="2857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600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A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C615CC-AB54-4666-AC09-B8F5560C31E0}"/>
              </a:ext>
            </a:extLst>
          </p:cNvPr>
          <p:cNvSpPr txBox="1"/>
          <p:nvPr/>
        </p:nvSpPr>
        <p:spPr>
          <a:xfrm>
            <a:off x="2330878" y="3374635"/>
            <a:ext cx="810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UO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2D0B8C6-5CC1-4E4C-8607-A5225E463994}"/>
              </a:ext>
            </a:extLst>
          </p:cNvPr>
          <p:cNvSpPr txBox="1"/>
          <p:nvPr/>
        </p:nvSpPr>
        <p:spPr>
          <a:xfrm>
            <a:off x="3356992" y="3392606"/>
            <a:ext cx="810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UO+NC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F0A25EB-54FB-4669-BB7F-257D1729B943}"/>
              </a:ext>
            </a:extLst>
          </p:cNvPr>
          <p:cNvSpPr txBox="1"/>
          <p:nvPr/>
        </p:nvSpPr>
        <p:spPr>
          <a:xfrm>
            <a:off x="4372151" y="3394146"/>
            <a:ext cx="921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UO+3607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6E315A6-23C7-44A1-B5BB-7610A0D3A285}"/>
              </a:ext>
            </a:extLst>
          </p:cNvPr>
          <p:cNvSpPr txBox="1"/>
          <p:nvPr/>
        </p:nvSpPr>
        <p:spPr>
          <a:xfrm>
            <a:off x="1200950" y="3382614"/>
            <a:ext cx="8100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100" b="1" dirty="0">
                <a:solidFill>
                  <a:prstClr val="black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ham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44" t="13845" b="16761"/>
          <a:stretch/>
        </p:blipFill>
        <p:spPr bwMode="auto">
          <a:xfrm>
            <a:off x="3841596" y="912045"/>
            <a:ext cx="2310975" cy="14439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1538921" y="545564"/>
            <a:ext cx="13337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R-3607-3p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551256" y="544198"/>
            <a:ext cx="11618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miR-4709-3p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6200000">
            <a:off x="304223" y="1490383"/>
            <a:ext cx="10111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tio to U6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6200000">
            <a:off x="3273067" y="1562391"/>
            <a:ext cx="101114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atio to U6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678570" y="816117"/>
            <a:ext cx="4286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###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671083" y="1055989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1160794" y="2324824"/>
            <a:ext cx="21241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ham   UUO    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U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U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+NC     +3607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110631" y="2364414"/>
            <a:ext cx="21241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Sham   UUO    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U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UO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 +NC     +4709</a:t>
            </a:r>
            <a:endParaRPr lang="zh-CN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2699042" y="924512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250068" y="1768904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768142" y="1896590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687559" y="926013"/>
            <a:ext cx="4286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#</a:t>
            </a:r>
            <a:endParaRPr kumimoji="0" lang="zh-CN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678310" y="1287241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5208545" y="1585717"/>
            <a:ext cx="4286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endParaRPr kumimoji="0" lang="zh-CN" altLang="en-US" sz="1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F0A25EB-54FB-4669-BB7F-257D1729B943}"/>
              </a:ext>
            </a:extLst>
          </p:cNvPr>
          <p:cNvSpPr txBox="1"/>
          <p:nvPr/>
        </p:nvSpPr>
        <p:spPr>
          <a:xfrm>
            <a:off x="5508200" y="3399349"/>
            <a:ext cx="921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UO+4709</a:t>
            </a:r>
            <a:endParaRPr kumimoji="0" lang="zh-CN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Picture 3" descr="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7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8833" y="365944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0781" y="3657303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22000"/>
                    </a14:imgEffect>
                    <a14:imgEffect>
                      <a14:colorTemperature colorTemp="5900"/>
                    </a14:imgEffect>
                    <a14:imgEffect>
                      <a14:saturation sat="8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7252" y="3654216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19628" y="47555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58837" y="47555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41819" y="47555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colorTemperature colorTemp="8746"/>
                    </a14:imgEffect>
                    <a14:imgEffect>
                      <a14:brightnessContrast bright="2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9946" y="4755500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298350" y="6285188"/>
            <a:ext cx="6291500" cy="2708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FontTx/>
              <a:buAutoNum type="alphaUcParenBoth"/>
            </a:pPr>
            <a:r>
              <a:rPr lang="en-US" altLang="zh-CN" sz="1000" dirty="0">
                <a:latin typeface="Arial" pitchFamily="34" charset="0"/>
                <a:cs typeface="Arial" pitchFamily="34" charset="0"/>
              </a:rPr>
              <a:t>Real-time PCR shows that levels of miR-3607-3p and miR-4709-3p are significantly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upregulated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in the transfection group. . Each bar represents the mean ± SEM for groups of six mice; *P &lt; 0.05, **P &lt; 0.01 versus sham-operated mice; #P &lt; 0.05, ###P &lt; 0.001 versus NC control treatment (UUO + NC).</a:t>
            </a:r>
            <a:r>
              <a:rPr lang="en-US" altLang="zh-CN" sz="1000" dirty="0"/>
              <a:t> </a:t>
            </a:r>
            <a:endParaRPr lang="en-US" altLang="zh-CN" sz="1000" dirty="0">
              <a:latin typeface="Arial" pitchFamily="34" charset="0"/>
              <a:cs typeface="Arial" pitchFamily="34" charset="0"/>
            </a:endParaRPr>
          </a:p>
          <a:p>
            <a:pPr marL="228600" indent="-228600" algn="just">
              <a:buAutoNum type="alphaUcParenBoth"/>
            </a:pPr>
            <a:r>
              <a:rPr lang="en-US" altLang="zh-CN" sz="1000" dirty="0">
                <a:latin typeface="Arial" pitchFamily="34" charset="0"/>
                <a:cs typeface="Arial" pitchFamily="34" charset="0"/>
              </a:rPr>
              <a:t>H&amp;E (upper panel) and Masson’s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trichrome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staining (lower panel) of mice kidney. Original magnification: ×400.</a:t>
            </a:r>
          </a:p>
          <a:p>
            <a:pPr algn="just"/>
            <a:endParaRPr lang="en-US" altLang="zh-CN" sz="1000" dirty="0">
              <a:latin typeface="Arial" pitchFamily="34" charset="0"/>
              <a:cs typeface="Arial" pitchFamily="34" charset="0"/>
            </a:endParaRPr>
          </a:p>
          <a:p>
            <a:pPr algn="just"/>
            <a:r>
              <a:rPr lang="en-US" altLang="zh-CN" sz="1000" dirty="0">
                <a:latin typeface="Arial" pitchFamily="34" charset="0"/>
                <a:cs typeface="Arial" pitchFamily="34" charset="0"/>
              </a:rPr>
              <a:t>Mouse model of UUO was induced in male C57BL/6J mice at 8 weeks of age (20–22 g body weight) and  miR-3607-3p and miR-4709-3p expressing plasmid was transfected into the left kidney as described earlier.[18,24] In brief, before the left ureter was ligated, groups of six mice received the mixed solution (200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μl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/mouse) containing either the microRNA expressing plasmid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pSuper.puro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vector or NC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pSuper.puro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vector (200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μg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/mouse) and lipid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microbubbles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 (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Sonovue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Bracco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, Milan, Italy) at a ratio of 1:1 (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vol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/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vol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) via the tail vein injection as described earlier.[18,24] Immediately after injection, an ultrasound transducer (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Therasonic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, Electro-Medical Supplies, </a:t>
            </a:r>
            <a:r>
              <a:rPr lang="en-US" altLang="zh-CN" sz="1000" dirty="0" err="1">
                <a:latin typeface="Arial" pitchFamily="34" charset="0"/>
                <a:cs typeface="Arial" pitchFamily="34" charset="0"/>
              </a:rPr>
              <a:t>Wantage</a:t>
            </a:r>
            <a:r>
              <a:rPr lang="en-US" altLang="zh-CN" sz="1000" dirty="0">
                <a:latin typeface="Arial" pitchFamily="34" charset="0"/>
                <a:cs typeface="Arial" pitchFamily="34" charset="0"/>
              </a:rPr>
              <a:t>, UK) was directly placed on the skin of the back against the left kidney with a pulse-wave output of 1 MHz at 2 W/cm2 for a total of 5 minutes. Kidney tissues were harvested at day 7 after the ultrasound treatment. In addition, groups of 6 sham-operated and UUO mice without ultrasound treatment were used as controls. The experimental procedures were performed following the approved protocol. </a:t>
            </a:r>
            <a:endParaRPr lang="zh-CN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 descr="E:\HK\experimental results\IHC\C57 UUO\Snap-6321.tiff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588" y="3646817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图片 7"/>
          <p:cNvPicPr preferRelativeResize="0">
            <a:picLocks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31000"/>
                    </a14:imgEffect>
                    <a14:imgEffect>
                      <a14:saturation sat="70000"/>
                    </a14:imgEffect>
                    <a14:imgEffect>
                      <a14:brightnessContrast bright="-1000" contrast="-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3240" y="4755500"/>
            <a:ext cx="1080000" cy="1080000"/>
          </a:xfrm>
          <a:prstGeom prst="rect">
            <a:avLst/>
          </a:prstGeom>
        </p:spPr>
      </p:pic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sharpenSoften amount="24000"/>
                    </a14:imgEffect>
                    <a14:imgEffect>
                      <a14:colorTemperature colorTemp="8413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94836" y="3646025"/>
            <a:ext cx="1080000" cy="108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5907242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</TotalTime>
  <Words>343</Words>
  <Application>Microsoft Office PowerPoint</Application>
  <PresentationFormat>On-screen Show (4:3)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宋体</vt:lpstr>
      <vt:lpstr>Arial</vt:lpstr>
      <vt:lpstr>Calibri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china</dc:creator>
  <cp:lastModifiedBy>yjwen86@126.com</cp:lastModifiedBy>
  <cp:revision>129</cp:revision>
  <dcterms:created xsi:type="dcterms:W3CDTF">2014-09-03T01:40:00Z</dcterms:created>
  <dcterms:modified xsi:type="dcterms:W3CDTF">2019-07-15T05:30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1.0.7452</vt:lpwstr>
  </property>
</Properties>
</file>